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png" ContentType="image/png"/>
  <Override PartName="/ppt/media/image4.jpeg" ContentType="image/jpe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684B4E-5F94-4791-B714-5F980730E7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7057B-4DB7-4417-B057-2FB86567C9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0DAE5F-9FCB-4E0B-AC0E-F287759B076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01A26C-694D-4340-9B4F-602CB5BB6AF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6D7242-966D-4A7C-8AAE-9CAF0BADF4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F1E0A7-FB6B-44C3-8359-166FD74698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7D0658-5B32-42FB-845B-E8CB0D5FCD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C0D042-B7AE-4F6F-8610-DBCBE1C772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AECABA-CD9F-42D0-BD6D-30341769E1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C0595C-077A-49E3-BABF-C0F8154019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7BDE77-9BD8-4EC8-BC2E-4F46B34ED6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2CDE4F-8A96-4740-B023-C266257AB6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11D5F6-40D1-4735-9915-3001F114915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1.jpeg"/><Relationship Id="rId4" Type="http://schemas.openxmlformats.org/officeDocument/2006/relationships/image" Target="../media/image1.jpeg"/><Relationship Id="rId5" Type="http://schemas.openxmlformats.org/officeDocument/2006/relationships/image" Target="../media/image2.jpeg"/><Relationship Id="rId6" Type="http://schemas.openxmlformats.org/officeDocument/2006/relationships/image" Target="../media/image3.png"/><Relationship Id="rId7" Type="http://schemas.openxmlformats.org/officeDocument/2006/relationships/image" Target="../media/image4.jpeg"/><Relationship Id="rId8" Type="http://schemas.openxmlformats.org/officeDocument/2006/relationships/image" Target="../media/image5.png"/><Relationship Id="rId9" Type="http://schemas.openxmlformats.org/officeDocument/2006/relationships/image" Target="../media/image6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50029" t="49876" r="0" b="0"/>
          <a:stretch/>
        </p:blipFill>
        <p:spPr>
          <a:xfrm>
            <a:off x="3459240" y="2151000"/>
            <a:ext cx="1079280" cy="99684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0" t="49896" r="49672" b="0"/>
          <a:stretch/>
        </p:blipFill>
        <p:spPr>
          <a:xfrm>
            <a:off x="2381400" y="2151000"/>
            <a:ext cx="1079280" cy="99684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rcRect l="49690" t="0" r="0" b="49493"/>
          <a:stretch/>
        </p:blipFill>
        <p:spPr>
          <a:xfrm>
            <a:off x="3449520" y="1166760"/>
            <a:ext cx="1079640" cy="99540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rcRect l="0" t="0" r="50018" b="49889"/>
          <a:stretch/>
        </p:blipFill>
        <p:spPr>
          <a:xfrm>
            <a:off x="2381400" y="1166760"/>
            <a:ext cx="1079280" cy="99540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2997360" y="1176480"/>
            <a:ext cx="502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85 gene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032360" y="1176480"/>
            <a:ext cx="528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81 gene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019320" y="2152800"/>
            <a:ext cx="484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21 gene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048200" y="2152800"/>
            <a:ext cx="617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12 gene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486240" y="2192400"/>
            <a:ext cx="352440" cy="55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8640" bIns="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6200000">
            <a:off x="2288520" y="2944440"/>
            <a:ext cx="307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 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rot="16200000">
            <a:off x="2399400" y="2920320"/>
            <a:ext cx="3621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E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6200000">
            <a:off x="2521440" y="2905560"/>
            <a:ext cx="3942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E18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rot="16200000">
            <a:off x="2657880" y="2905560"/>
            <a:ext cx="3942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E2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6200000">
            <a:off x="2859120" y="2950920"/>
            <a:ext cx="2934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6200000">
            <a:off x="2959920" y="2918160"/>
            <a:ext cx="365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E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rot="16200000">
            <a:off x="3081960" y="2903760"/>
            <a:ext cx="397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E18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16200000">
            <a:off x="3205800" y="2903760"/>
            <a:ext cx="397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E2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rot="16200000">
            <a:off x="3355560" y="2944440"/>
            <a:ext cx="307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 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rot="16200000">
            <a:off x="3444120" y="2920320"/>
            <a:ext cx="3621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E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rot="16200000">
            <a:off x="3569040" y="2905560"/>
            <a:ext cx="3942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E18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rot="16200000">
            <a:off x="3715200" y="2905560"/>
            <a:ext cx="3942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E2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rot="16200000">
            <a:off x="3919680" y="2950920"/>
            <a:ext cx="2934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6200000">
            <a:off x="4026600" y="2918160"/>
            <a:ext cx="3650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E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rot="16200000">
            <a:off x="4148640" y="2903760"/>
            <a:ext cx="397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E18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rot="16200000">
            <a:off x="4272480" y="2903760"/>
            <a:ext cx="397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E2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444760" y="2209680"/>
            <a:ext cx="352440" cy="55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432160" y="1230480"/>
            <a:ext cx="352440" cy="55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8640" bIns="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498840" y="1236600"/>
            <a:ext cx="352440" cy="55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520000" y="912960"/>
            <a:ext cx="190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EGF </a:t>
            </a:r>
            <a:r>
              <a:rPr b="0" i="1" lang="en-GB" sz="1400" spc="-1" strike="noStrike">
                <a:solidFill>
                  <a:srgbClr val="000000"/>
                </a:solidFill>
                <a:latin typeface="Times New Roman"/>
              </a:rPr>
              <a:t>k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-means cluster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353320" y="1174680"/>
            <a:ext cx="253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(i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420000" y="1174680"/>
            <a:ext cx="275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(ii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343240" y="2143080"/>
            <a:ext cx="2966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(iii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410640" y="2133720"/>
            <a:ext cx="2919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(iv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" descr=""/>
          <p:cNvPicPr/>
          <p:nvPr/>
        </p:nvPicPr>
        <p:blipFill>
          <a:blip r:embed="rId5">
            <a:lum contrast="6000"/>
          </a:blip>
          <a:srcRect l="69044" t="13941" r="20278" b="48022"/>
          <a:stretch/>
        </p:blipFill>
        <p:spPr>
          <a:xfrm>
            <a:off x="2971800" y="4419720"/>
            <a:ext cx="581040" cy="1620720"/>
          </a:xfrm>
          <a:prstGeom prst="rect">
            <a:avLst/>
          </a:prstGeom>
          <a:ln w="0">
            <a:noFill/>
          </a:ln>
        </p:spPr>
      </p:pic>
      <p:pic>
        <p:nvPicPr>
          <p:cNvPr id="75" name="" descr=""/>
          <p:cNvPicPr/>
          <p:nvPr/>
        </p:nvPicPr>
        <p:blipFill>
          <a:blip r:embed="rId6"/>
          <a:srcRect l="0" t="13596" r="30500" b="48022"/>
          <a:stretch/>
        </p:blipFill>
        <p:spPr>
          <a:xfrm>
            <a:off x="1085760" y="4429080"/>
            <a:ext cx="1962360" cy="1635120"/>
          </a:xfrm>
          <a:prstGeom prst="rect">
            <a:avLst/>
          </a:prstGeom>
          <a:ln w="0">
            <a:noFill/>
          </a:ln>
        </p:spPr>
      </p:pic>
      <p:grpSp>
        <p:nvGrpSpPr>
          <p:cNvPr id="76" name=""/>
          <p:cNvGrpSpPr/>
          <p:nvPr/>
        </p:nvGrpSpPr>
        <p:grpSpPr>
          <a:xfrm>
            <a:off x="1311120" y="3666960"/>
            <a:ext cx="1707840" cy="866880"/>
            <a:chOff x="1311120" y="3666960"/>
            <a:chExt cx="1707840" cy="866880"/>
          </a:xfrm>
        </p:grpSpPr>
        <p:sp>
          <p:nvSpPr>
            <p:cNvPr id="77" name=""/>
            <p:cNvSpPr/>
            <p:nvPr/>
          </p:nvSpPr>
          <p:spPr>
            <a:xfrm rot="16200000">
              <a:off x="1195920" y="4223160"/>
              <a:ext cx="4154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rot="16200000">
              <a:off x="1310400" y="4130640"/>
              <a:ext cx="6181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rot="16200000">
              <a:off x="1509120" y="4113000"/>
              <a:ext cx="656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rot="16200000">
              <a:off x="1726560" y="4113000"/>
              <a:ext cx="656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rot="16200000">
              <a:off x="2195640" y="4145400"/>
              <a:ext cx="587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rot="16200000">
              <a:off x="2395800" y="4127400"/>
              <a:ext cx="625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rot="16200000">
              <a:off x="2613240" y="4127400"/>
              <a:ext cx="625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rot="16200000">
              <a:off x="2079720" y="4238280"/>
              <a:ext cx="384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rot="5400000">
              <a:off x="2085120" y="3081960"/>
              <a:ext cx="108000" cy="1629000"/>
            </a:xfrm>
            <a:custGeom>
              <a:avLst/>
              <a:gdLst>
                <a:gd name="textAreaLeft" fmla="*/ 69120 w 108000"/>
                <a:gd name="textAreaRight" fmla="*/ 108360 w 108000"/>
                <a:gd name="textAreaTop" fmla="*/ 42480 h 1629000"/>
                <a:gd name="textAreaBottom" fmla="*/ 1586520 h 1629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877760" y="3666960"/>
              <a:ext cx="52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F rati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7" name=""/>
          <p:cNvSpPr/>
          <p:nvPr/>
        </p:nvSpPr>
        <p:spPr>
          <a:xfrm>
            <a:off x="882000" y="3762360"/>
            <a:ext cx="40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(iii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186720" y="3762360"/>
            <a:ext cx="4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(iv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9" name=""/>
          <p:cNvGrpSpPr/>
          <p:nvPr/>
        </p:nvGrpSpPr>
        <p:grpSpPr>
          <a:xfrm>
            <a:off x="3552840" y="3666960"/>
            <a:ext cx="2457360" cy="1790640"/>
            <a:chOff x="3552840" y="3666960"/>
            <a:chExt cx="2457360" cy="1790640"/>
          </a:xfrm>
        </p:grpSpPr>
        <p:pic>
          <p:nvPicPr>
            <p:cNvPr id="90" name="" descr=""/>
            <p:cNvPicPr/>
            <p:nvPr/>
          </p:nvPicPr>
          <p:blipFill>
            <a:blip r:embed="rId7">
              <a:lum contrast="6000"/>
            </a:blip>
            <a:srcRect l="70747" t="13941" r="18424" b="64032"/>
            <a:stretch/>
          </p:blipFill>
          <p:spPr>
            <a:xfrm>
              <a:off x="5476680" y="4427280"/>
              <a:ext cx="533520" cy="825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" descr=""/>
            <p:cNvPicPr/>
            <p:nvPr/>
          </p:nvPicPr>
          <p:blipFill>
            <a:blip r:embed="rId8"/>
            <a:srcRect l="0" t="13941" r="29259" b="64032"/>
            <a:stretch/>
          </p:blipFill>
          <p:spPr>
            <a:xfrm>
              <a:off x="3552840" y="4445280"/>
              <a:ext cx="1962000" cy="7992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92" name=""/>
            <p:cNvGrpSpPr/>
            <p:nvPr/>
          </p:nvGrpSpPr>
          <p:grpSpPr>
            <a:xfrm>
              <a:off x="3797280" y="3666960"/>
              <a:ext cx="1707840" cy="874440"/>
              <a:chOff x="3797280" y="3666960"/>
              <a:chExt cx="1707840" cy="874440"/>
            </a:xfrm>
          </p:grpSpPr>
          <p:sp>
            <p:nvSpPr>
              <p:cNvPr id="93" name=""/>
              <p:cNvSpPr/>
              <p:nvPr/>
            </p:nvSpPr>
            <p:spPr>
              <a:xfrm rot="16200000">
                <a:off x="3682080" y="4231440"/>
                <a:ext cx="4154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600" spc="-1" strike="noStrike">
                    <a:solidFill>
                      <a:srgbClr val="000000"/>
                    </a:solidFill>
                    <a:latin typeface="Times New Roman"/>
                  </a:rPr>
                  <a:t>HB4a 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 rot="16200000">
                <a:off x="3796560" y="4138200"/>
                <a:ext cx="61812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600" spc="-1" strike="noStrike">
                    <a:solidFill>
                      <a:srgbClr val="000000"/>
                    </a:solidFill>
                    <a:latin typeface="Times New Roman"/>
                  </a:rPr>
                  <a:t>HB4a EGF 4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 rot="16200000">
                <a:off x="3995280" y="4120560"/>
                <a:ext cx="6562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600" spc="-1" strike="noStrike">
                    <a:solidFill>
                      <a:srgbClr val="000000"/>
                    </a:solidFill>
                    <a:latin typeface="Times New Roman"/>
                  </a:rPr>
                  <a:t>HB4a EGF 18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 rot="16200000">
                <a:off x="4212720" y="4120560"/>
                <a:ext cx="6562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600" spc="-1" strike="noStrike">
                    <a:solidFill>
                      <a:srgbClr val="000000"/>
                    </a:solidFill>
                    <a:latin typeface="Times New Roman"/>
                  </a:rPr>
                  <a:t>HB4a EGF 24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 rot="16200000">
                <a:off x="4681800" y="4152600"/>
                <a:ext cx="58752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600" spc="-1" strike="noStrike">
                    <a:solidFill>
                      <a:srgbClr val="000000"/>
                    </a:solidFill>
                    <a:latin typeface="Times New Roman"/>
                  </a:rPr>
                  <a:t>C3.6 EGF 4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 rot="16200000">
                <a:off x="4881960" y="4135320"/>
                <a:ext cx="6256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600" spc="-1" strike="noStrike">
                    <a:solidFill>
                      <a:srgbClr val="000000"/>
                    </a:solidFill>
                    <a:latin typeface="Times New Roman"/>
                  </a:rPr>
                  <a:t>C3.6 EGF 18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 rot="16200000">
                <a:off x="5099400" y="4135320"/>
                <a:ext cx="6256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600" spc="-1" strike="noStrike">
                    <a:solidFill>
                      <a:srgbClr val="000000"/>
                    </a:solidFill>
                    <a:latin typeface="Times New Roman"/>
                  </a:rPr>
                  <a:t>C3.6 EGF 24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 rot="16200000">
                <a:off x="4565880" y="4246200"/>
                <a:ext cx="3848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600" spc="-1" strike="noStrike">
                    <a:solidFill>
                      <a:srgbClr val="000000"/>
                    </a:solidFill>
                    <a:latin typeface="Times New Roman"/>
                  </a:rPr>
                  <a:t>C3.6 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 rot="5400000">
                <a:off x="4570920" y="3084480"/>
                <a:ext cx="109080" cy="1629000"/>
              </a:xfrm>
              <a:custGeom>
                <a:avLst/>
                <a:gdLst>
                  <a:gd name="textAreaLeft" fmla="*/ 69840 w 109080"/>
                  <a:gd name="textAreaRight" fmla="*/ 109440 w 109080"/>
                  <a:gd name="textAreaTop" fmla="*/ 42480 h 1629000"/>
                  <a:gd name="textAreaBottom" fmla="*/ 1586520 h 1629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900"/>
                      <a:pt x="10800" y="1800"/>
                    </a:cubicBezTo>
                    <a:lnTo>
                      <a:pt x="10800" y="9000"/>
                    </a:lnTo>
                    <a:cubicBezTo>
                      <a:pt x="10800" y="9900"/>
                      <a:pt x="5400" y="10800"/>
                      <a:pt x="0" y="10800"/>
                    </a:cubicBezTo>
                    <a:cubicBezTo>
                      <a:pt x="5400" y="10800"/>
                      <a:pt x="10800" y="11700"/>
                      <a:pt x="10800" y="12600"/>
                    </a:cubicBezTo>
                    <a:lnTo>
                      <a:pt x="10800" y="19800"/>
                    </a:lnTo>
                    <a:cubicBezTo>
                      <a:pt x="10800" y="20700"/>
                      <a:pt x="162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4363920" y="3666960"/>
                <a:ext cx="525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Times New Roman"/>
                  </a:rPr>
                  <a:t>GF ratio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103" name="" descr=""/>
            <p:cNvPicPr/>
            <p:nvPr/>
          </p:nvPicPr>
          <p:blipFill>
            <a:blip r:embed="rId9"/>
            <a:stretch/>
          </p:blipFill>
          <p:spPr>
            <a:xfrm>
              <a:off x="4543200" y="5247360"/>
              <a:ext cx="993960" cy="2102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0T10:41:22Z</dcterms:created>
  <dc:creator>John Timms</dc:creator>
  <dc:description/>
  <dc:language>en-US</dc:language>
  <cp:lastModifiedBy>John Timms</cp:lastModifiedBy>
  <dcterms:modified xsi:type="dcterms:W3CDTF">2010-09-10T10:41:46Z</dcterms:modified>
  <cp:revision>1</cp:revision>
  <dc:subject/>
  <dc:title>Slide 1</dc:title>
</cp:coreProperties>
</file>